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1" autoAdjust="0"/>
    <p:restoredTop sz="94660"/>
  </p:normalViewPr>
  <p:slideViewPr>
    <p:cSldViewPr snapToGrid="0">
      <p:cViewPr varScale="1">
        <p:scale>
          <a:sx n="45" d="100"/>
          <a:sy n="45" d="100"/>
        </p:scale>
        <p:origin x="24" y="9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F5BF0-695F-48CC-B5A5-15884D9532A6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F81E1-1F83-419F-8B07-DB30CD3905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57878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F5BF0-695F-48CC-B5A5-15884D9532A6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F81E1-1F83-419F-8B07-DB30CD3905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76561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F5BF0-695F-48CC-B5A5-15884D9532A6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F81E1-1F83-419F-8B07-DB30CD3905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17273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F5BF0-695F-48CC-B5A5-15884D9532A6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F81E1-1F83-419F-8B07-DB30CD3905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98266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F5BF0-695F-48CC-B5A5-15884D9532A6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F81E1-1F83-419F-8B07-DB30CD3905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03444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F5BF0-695F-48CC-B5A5-15884D9532A6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F81E1-1F83-419F-8B07-DB30CD3905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93423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F5BF0-695F-48CC-B5A5-15884D9532A6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F81E1-1F83-419F-8B07-DB30CD3905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93235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F5BF0-695F-48CC-B5A5-15884D9532A6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F81E1-1F83-419F-8B07-DB30CD3905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1833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F5BF0-695F-48CC-B5A5-15884D9532A6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F81E1-1F83-419F-8B07-DB30CD3905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12163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F5BF0-695F-48CC-B5A5-15884D9532A6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F81E1-1F83-419F-8B07-DB30CD3905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4122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F5BF0-695F-48CC-B5A5-15884D9532A6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F81E1-1F83-419F-8B07-DB30CD3905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19217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9F5BF0-695F-48CC-B5A5-15884D9532A6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5F81E1-1F83-419F-8B07-DB30CD3905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61808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15496" y="731520"/>
            <a:ext cx="9161008" cy="4921250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762000" y="5875867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igure S18.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Correlation between β-haematin inhibition activity (log(BIHA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)) and 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(log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­)) for reversed chloroquinolines against resistant strain Dd2</a:t>
            </a: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613081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c Nguyen</dc:creator>
  <cp:lastModifiedBy>Ngoc Nguyen</cp:lastModifiedBy>
  <cp:revision>2</cp:revision>
  <dcterms:created xsi:type="dcterms:W3CDTF">2020-07-03T16:09:46Z</dcterms:created>
  <dcterms:modified xsi:type="dcterms:W3CDTF">2020-08-04T16:34:42Z</dcterms:modified>
</cp:coreProperties>
</file>